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notesMasterIdLst>
    <p:notesMasterId r:id="rId3"/>
  </p:notesMasterIdLst>
  <p:sldIdLst>
    <p:sldId id="259" r:id="rId2"/>
  </p:sldIdLst>
  <p:sldSz cx="15932150" cy="89614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597"/>
    <p:restoredTop sz="96715"/>
  </p:normalViewPr>
  <p:slideViewPr>
    <p:cSldViewPr snapToGrid="0" snapToObjects="1">
      <p:cViewPr varScale="1">
        <p:scale>
          <a:sx n="90" d="100"/>
          <a:sy n="90" d="100"/>
        </p:scale>
        <p:origin x="488" y="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33E5502-1FBC-0042-B006-43458C8AC609}" type="datetimeFigureOut">
              <a:rPr lang="en-US" smtClean="0"/>
              <a:t>1/1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BF477B4-3C76-6F4B-A9D1-B28F2B1882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739696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Google Shape;87;p2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  <p:sp>
        <p:nvSpPr>
          <p:cNvPr id="88" name="Google Shape;88;p2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117002165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991519" y="1466606"/>
            <a:ext cx="11949113" cy="3119908"/>
          </a:xfrm>
        </p:spPr>
        <p:txBody>
          <a:bodyPr anchor="b"/>
          <a:lstStyle>
            <a:lvl1pPr algn="ctr">
              <a:defRPr sz="78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991519" y="4706830"/>
            <a:ext cx="11949113" cy="2163606"/>
          </a:xfrm>
        </p:spPr>
        <p:txBody>
          <a:bodyPr/>
          <a:lstStyle>
            <a:lvl1pPr marL="0" indent="0" algn="ctr">
              <a:buNone/>
              <a:defRPr sz="3136"/>
            </a:lvl1pPr>
            <a:lvl2pPr marL="597423" indent="0" algn="ctr">
              <a:buNone/>
              <a:defRPr sz="2613"/>
            </a:lvl2pPr>
            <a:lvl3pPr marL="1194846" indent="0" algn="ctr">
              <a:buNone/>
              <a:defRPr sz="2352"/>
            </a:lvl3pPr>
            <a:lvl4pPr marL="1792270" indent="0" algn="ctr">
              <a:buNone/>
              <a:defRPr sz="2091"/>
            </a:lvl4pPr>
            <a:lvl5pPr marL="2389693" indent="0" algn="ctr">
              <a:buNone/>
              <a:defRPr sz="2091"/>
            </a:lvl5pPr>
            <a:lvl6pPr marL="2987116" indent="0" algn="ctr">
              <a:buNone/>
              <a:defRPr sz="2091"/>
            </a:lvl6pPr>
            <a:lvl7pPr marL="3584539" indent="0" algn="ctr">
              <a:buNone/>
              <a:defRPr sz="2091"/>
            </a:lvl7pPr>
            <a:lvl8pPr marL="4181963" indent="0" algn="ctr">
              <a:buNone/>
              <a:defRPr sz="2091"/>
            </a:lvl8pPr>
            <a:lvl9pPr marL="4779386" indent="0" algn="ctr">
              <a:buNone/>
              <a:defRPr sz="2091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889664-954F-594A-B5AF-FCA2FEB7744B}" type="datetimeFigureOut">
              <a:rPr lang="en-US" smtClean="0"/>
              <a:t>1/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51B486-F3E4-8B40-8B62-0DDBC71E83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21002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889664-954F-594A-B5AF-FCA2FEB7744B}" type="datetimeFigureOut">
              <a:rPr lang="en-US" smtClean="0"/>
              <a:t>1/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51B486-F3E4-8B40-8B62-0DDBC71E83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45471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1401445" y="477114"/>
            <a:ext cx="3435370" cy="7594404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095335" y="477114"/>
            <a:ext cx="10106958" cy="7594404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889664-954F-594A-B5AF-FCA2FEB7744B}" type="datetimeFigureOut">
              <a:rPr lang="en-US" smtClean="0"/>
              <a:t>1/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51B486-F3E4-8B40-8B62-0DDBC71E83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39257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889664-954F-594A-B5AF-FCA2FEB7744B}" type="datetimeFigureOut">
              <a:rPr lang="en-US" smtClean="0"/>
              <a:t>1/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51B486-F3E4-8B40-8B62-0DDBC71E83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28232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87038" y="2234137"/>
            <a:ext cx="13741479" cy="3727709"/>
          </a:xfrm>
        </p:spPr>
        <p:txBody>
          <a:bodyPr anchor="b"/>
          <a:lstStyle>
            <a:lvl1pPr>
              <a:defRPr sz="78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87038" y="5997112"/>
            <a:ext cx="13741479" cy="1960314"/>
          </a:xfrm>
        </p:spPr>
        <p:txBody>
          <a:bodyPr/>
          <a:lstStyle>
            <a:lvl1pPr marL="0" indent="0">
              <a:buNone/>
              <a:defRPr sz="3136">
                <a:solidFill>
                  <a:schemeClr val="tx1">
                    <a:tint val="75000"/>
                  </a:schemeClr>
                </a:solidFill>
              </a:defRPr>
            </a:lvl1pPr>
            <a:lvl2pPr marL="597423" indent="0">
              <a:buNone/>
              <a:defRPr sz="2613">
                <a:solidFill>
                  <a:schemeClr val="tx1">
                    <a:tint val="75000"/>
                  </a:schemeClr>
                </a:solidFill>
              </a:defRPr>
            </a:lvl2pPr>
            <a:lvl3pPr marL="1194846" indent="0">
              <a:buNone/>
              <a:defRPr sz="2352">
                <a:solidFill>
                  <a:schemeClr val="tx1">
                    <a:tint val="75000"/>
                  </a:schemeClr>
                </a:solidFill>
              </a:defRPr>
            </a:lvl3pPr>
            <a:lvl4pPr marL="1792270" indent="0">
              <a:buNone/>
              <a:defRPr sz="2091">
                <a:solidFill>
                  <a:schemeClr val="tx1">
                    <a:tint val="75000"/>
                  </a:schemeClr>
                </a:solidFill>
              </a:defRPr>
            </a:lvl4pPr>
            <a:lvl5pPr marL="2389693" indent="0">
              <a:buNone/>
              <a:defRPr sz="2091">
                <a:solidFill>
                  <a:schemeClr val="tx1">
                    <a:tint val="75000"/>
                  </a:schemeClr>
                </a:solidFill>
              </a:defRPr>
            </a:lvl5pPr>
            <a:lvl6pPr marL="2987116" indent="0">
              <a:buNone/>
              <a:defRPr sz="2091">
                <a:solidFill>
                  <a:schemeClr val="tx1">
                    <a:tint val="75000"/>
                  </a:schemeClr>
                </a:solidFill>
              </a:defRPr>
            </a:lvl6pPr>
            <a:lvl7pPr marL="3584539" indent="0">
              <a:buNone/>
              <a:defRPr sz="2091">
                <a:solidFill>
                  <a:schemeClr val="tx1">
                    <a:tint val="75000"/>
                  </a:schemeClr>
                </a:solidFill>
              </a:defRPr>
            </a:lvl7pPr>
            <a:lvl8pPr marL="4181963" indent="0">
              <a:buNone/>
              <a:defRPr sz="2091">
                <a:solidFill>
                  <a:schemeClr val="tx1">
                    <a:tint val="75000"/>
                  </a:schemeClr>
                </a:solidFill>
              </a:defRPr>
            </a:lvl8pPr>
            <a:lvl9pPr marL="4779386" indent="0">
              <a:buNone/>
              <a:defRPr sz="209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889664-954F-594A-B5AF-FCA2FEB7744B}" type="datetimeFigureOut">
              <a:rPr lang="en-US" smtClean="0"/>
              <a:t>1/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51B486-F3E4-8B40-8B62-0DDBC71E83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18326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095335" y="2385568"/>
            <a:ext cx="6771164" cy="568595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065651" y="2385568"/>
            <a:ext cx="6771164" cy="568595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889664-954F-594A-B5AF-FCA2FEB7744B}" type="datetimeFigureOut">
              <a:rPr lang="en-US" smtClean="0"/>
              <a:t>1/1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51B486-F3E4-8B40-8B62-0DDBC71E83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1590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97411" y="477114"/>
            <a:ext cx="13741479" cy="1732130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97411" y="2196797"/>
            <a:ext cx="6740046" cy="1076617"/>
          </a:xfrm>
        </p:spPr>
        <p:txBody>
          <a:bodyPr anchor="b"/>
          <a:lstStyle>
            <a:lvl1pPr marL="0" indent="0">
              <a:buNone/>
              <a:defRPr sz="3136" b="1"/>
            </a:lvl1pPr>
            <a:lvl2pPr marL="597423" indent="0">
              <a:buNone/>
              <a:defRPr sz="2613" b="1"/>
            </a:lvl2pPr>
            <a:lvl3pPr marL="1194846" indent="0">
              <a:buNone/>
              <a:defRPr sz="2352" b="1"/>
            </a:lvl3pPr>
            <a:lvl4pPr marL="1792270" indent="0">
              <a:buNone/>
              <a:defRPr sz="2091" b="1"/>
            </a:lvl4pPr>
            <a:lvl5pPr marL="2389693" indent="0">
              <a:buNone/>
              <a:defRPr sz="2091" b="1"/>
            </a:lvl5pPr>
            <a:lvl6pPr marL="2987116" indent="0">
              <a:buNone/>
              <a:defRPr sz="2091" b="1"/>
            </a:lvl6pPr>
            <a:lvl7pPr marL="3584539" indent="0">
              <a:buNone/>
              <a:defRPr sz="2091" b="1"/>
            </a:lvl7pPr>
            <a:lvl8pPr marL="4181963" indent="0">
              <a:buNone/>
              <a:defRPr sz="2091" b="1"/>
            </a:lvl8pPr>
            <a:lvl9pPr marL="4779386" indent="0">
              <a:buNone/>
              <a:defRPr sz="2091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97411" y="3273414"/>
            <a:ext cx="6740046" cy="481469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8065651" y="2196797"/>
            <a:ext cx="6773239" cy="1076617"/>
          </a:xfrm>
        </p:spPr>
        <p:txBody>
          <a:bodyPr anchor="b"/>
          <a:lstStyle>
            <a:lvl1pPr marL="0" indent="0">
              <a:buNone/>
              <a:defRPr sz="3136" b="1"/>
            </a:lvl1pPr>
            <a:lvl2pPr marL="597423" indent="0">
              <a:buNone/>
              <a:defRPr sz="2613" b="1"/>
            </a:lvl2pPr>
            <a:lvl3pPr marL="1194846" indent="0">
              <a:buNone/>
              <a:defRPr sz="2352" b="1"/>
            </a:lvl3pPr>
            <a:lvl4pPr marL="1792270" indent="0">
              <a:buNone/>
              <a:defRPr sz="2091" b="1"/>
            </a:lvl4pPr>
            <a:lvl5pPr marL="2389693" indent="0">
              <a:buNone/>
              <a:defRPr sz="2091" b="1"/>
            </a:lvl5pPr>
            <a:lvl6pPr marL="2987116" indent="0">
              <a:buNone/>
              <a:defRPr sz="2091" b="1"/>
            </a:lvl6pPr>
            <a:lvl7pPr marL="3584539" indent="0">
              <a:buNone/>
              <a:defRPr sz="2091" b="1"/>
            </a:lvl7pPr>
            <a:lvl8pPr marL="4181963" indent="0">
              <a:buNone/>
              <a:defRPr sz="2091" b="1"/>
            </a:lvl8pPr>
            <a:lvl9pPr marL="4779386" indent="0">
              <a:buNone/>
              <a:defRPr sz="2091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8065651" y="3273414"/>
            <a:ext cx="6773239" cy="481469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889664-954F-594A-B5AF-FCA2FEB7744B}" type="datetimeFigureOut">
              <a:rPr lang="en-US" smtClean="0"/>
              <a:t>1/1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51B486-F3E4-8B40-8B62-0DDBC71E83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94842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889664-954F-594A-B5AF-FCA2FEB7744B}" type="datetimeFigureOut">
              <a:rPr lang="en-US" smtClean="0"/>
              <a:t>1/1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51B486-F3E4-8B40-8B62-0DDBC71E83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61838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889664-954F-594A-B5AF-FCA2FEB7744B}" type="datetimeFigureOut">
              <a:rPr lang="en-US" smtClean="0"/>
              <a:t>1/1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51B486-F3E4-8B40-8B62-0DDBC71E83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18782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97411" y="597429"/>
            <a:ext cx="5138533" cy="2091002"/>
          </a:xfrm>
        </p:spPr>
        <p:txBody>
          <a:bodyPr anchor="b"/>
          <a:lstStyle>
            <a:lvl1pPr>
              <a:defRPr sz="418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773239" y="1290282"/>
            <a:ext cx="8065651" cy="6368429"/>
          </a:xfrm>
        </p:spPr>
        <p:txBody>
          <a:bodyPr/>
          <a:lstStyle>
            <a:lvl1pPr>
              <a:defRPr sz="4181"/>
            </a:lvl1pPr>
            <a:lvl2pPr>
              <a:defRPr sz="3659"/>
            </a:lvl2pPr>
            <a:lvl3pPr>
              <a:defRPr sz="3136"/>
            </a:lvl3pPr>
            <a:lvl4pPr>
              <a:defRPr sz="2613"/>
            </a:lvl4pPr>
            <a:lvl5pPr>
              <a:defRPr sz="2613"/>
            </a:lvl5pPr>
            <a:lvl6pPr>
              <a:defRPr sz="2613"/>
            </a:lvl6pPr>
            <a:lvl7pPr>
              <a:defRPr sz="2613"/>
            </a:lvl7pPr>
            <a:lvl8pPr>
              <a:defRPr sz="2613"/>
            </a:lvl8pPr>
            <a:lvl9pPr>
              <a:defRPr sz="2613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97411" y="2688431"/>
            <a:ext cx="5138533" cy="4980652"/>
          </a:xfrm>
        </p:spPr>
        <p:txBody>
          <a:bodyPr/>
          <a:lstStyle>
            <a:lvl1pPr marL="0" indent="0">
              <a:buNone/>
              <a:defRPr sz="2091"/>
            </a:lvl1pPr>
            <a:lvl2pPr marL="597423" indent="0">
              <a:buNone/>
              <a:defRPr sz="1829"/>
            </a:lvl2pPr>
            <a:lvl3pPr marL="1194846" indent="0">
              <a:buNone/>
              <a:defRPr sz="1568"/>
            </a:lvl3pPr>
            <a:lvl4pPr marL="1792270" indent="0">
              <a:buNone/>
              <a:defRPr sz="1307"/>
            </a:lvl4pPr>
            <a:lvl5pPr marL="2389693" indent="0">
              <a:buNone/>
              <a:defRPr sz="1307"/>
            </a:lvl5pPr>
            <a:lvl6pPr marL="2987116" indent="0">
              <a:buNone/>
              <a:defRPr sz="1307"/>
            </a:lvl6pPr>
            <a:lvl7pPr marL="3584539" indent="0">
              <a:buNone/>
              <a:defRPr sz="1307"/>
            </a:lvl7pPr>
            <a:lvl8pPr marL="4181963" indent="0">
              <a:buNone/>
              <a:defRPr sz="1307"/>
            </a:lvl8pPr>
            <a:lvl9pPr marL="4779386" indent="0">
              <a:buNone/>
              <a:defRPr sz="130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889664-954F-594A-B5AF-FCA2FEB7744B}" type="datetimeFigureOut">
              <a:rPr lang="en-US" smtClean="0"/>
              <a:t>1/1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51B486-F3E4-8B40-8B62-0DDBC71E83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50046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97411" y="597429"/>
            <a:ext cx="5138533" cy="2091002"/>
          </a:xfrm>
        </p:spPr>
        <p:txBody>
          <a:bodyPr anchor="b"/>
          <a:lstStyle>
            <a:lvl1pPr>
              <a:defRPr sz="418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773239" y="1290282"/>
            <a:ext cx="8065651" cy="6368429"/>
          </a:xfrm>
        </p:spPr>
        <p:txBody>
          <a:bodyPr anchor="t"/>
          <a:lstStyle>
            <a:lvl1pPr marL="0" indent="0">
              <a:buNone/>
              <a:defRPr sz="4181"/>
            </a:lvl1pPr>
            <a:lvl2pPr marL="597423" indent="0">
              <a:buNone/>
              <a:defRPr sz="3659"/>
            </a:lvl2pPr>
            <a:lvl3pPr marL="1194846" indent="0">
              <a:buNone/>
              <a:defRPr sz="3136"/>
            </a:lvl3pPr>
            <a:lvl4pPr marL="1792270" indent="0">
              <a:buNone/>
              <a:defRPr sz="2613"/>
            </a:lvl4pPr>
            <a:lvl5pPr marL="2389693" indent="0">
              <a:buNone/>
              <a:defRPr sz="2613"/>
            </a:lvl5pPr>
            <a:lvl6pPr marL="2987116" indent="0">
              <a:buNone/>
              <a:defRPr sz="2613"/>
            </a:lvl6pPr>
            <a:lvl7pPr marL="3584539" indent="0">
              <a:buNone/>
              <a:defRPr sz="2613"/>
            </a:lvl7pPr>
            <a:lvl8pPr marL="4181963" indent="0">
              <a:buNone/>
              <a:defRPr sz="2613"/>
            </a:lvl8pPr>
            <a:lvl9pPr marL="4779386" indent="0">
              <a:buNone/>
              <a:defRPr sz="2613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97411" y="2688431"/>
            <a:ext cx="5138533" cy="4980652"/>
          </a:xfrm>
        </p:spPr>
        <p:txBody>
          <a:bodyPr/>
          <a:lstStyle>
            <a:lvl1pPr marL="0" indent="0">
              <a:buNone/>
              <a:defRPr sz="2091"/>
            </a:lvl1pPr>
            <a:lvl2pPr marL="597423" indent="0">
              <a:buNone/>
              <a:defRPr sz="1829"/>
            </a:lvl2pPr>
            <a:lvl3pPr marL="1194846" indent="0">
              <a:buNone/>
              <a:defRPr sz="1568"/>
            </a:lvl3pPr>
            <a:lvl4pPr marL="1792270" indent="0">
              <a:buNone/>
              <a:defRPr sz="1307"/>
            </a:lvl4pPr>
            <a:lvl5pPr marL="2389693" indent="0">
              <a:buNone/>
              <a:defRPr sz="1307"/>
            </a:lvl5pPr>
            <a:lvl6pPr marL="2987116" indent="0">
              <a:buNone/>
              <a:defRPr sz="1307"/>
            </a:lvl6pPr>
            <a:lvl7pPr marL="3584539" indent="0">
              <a:buNone/>
              <a:defRPr sz="1307"/>
            </a:lvl7pPr>
            <a:lvl8pPr marL="4181963" indent="0">
              <a:buNone/>
              <a:defRPr sz="1307"/>
            </a:lvl8pPr>
            <a:lvl9pPr marL="4779386" indent="0">
              <a:buNone/>
              <a:defRPr sz="130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889664-954F-594A-B5AF-FCA2FEB7744B}" type="datetimeFigureOut">
              <a:rPr lang="en-US" smtClean="0"/>
              <a:t>1/1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51B486-F3E4-8B40-8B62-0DDBC71E83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74220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095336" y="477114"/>
            <a:ext cx="13741479" cy="173213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95336" y="2385568"/>
            <a:ext cx="13741479" cy="568595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095335" y="8305926"/>
            <a:ext cx="3584734" cy="47711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56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889664-954F-594A-B5AF-FCA2FEB7744B}" type="datetimeFigureOut">
              <a:rPr lang="en-US" smtClean="0"/>
              <a:t>1/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277525" y="8305926"/>
            <a:ext cx="5377101" cy="47711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56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1252081" y="8305926"/>
            <a:ext cx="3584734" cy="47711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56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51B486-F3E4-8B40-8B62-0DDBC71E83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51455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194846" rtl="0" eaLnBrk="1" latinLnBrk="0" hangingPunct="1">
        <a:lnSpc>
          <a:spcPct val="90000"/>
        </a:lnSpc>
        <a:spcBef>
          <a:spcPct val="0"/>
        </a:spcBef>
        <a:buNone/>
        <a:defRPr sz="574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98712" indent="-298712" algn="l" defTabSz="1194846" rtl="0" eaLnBrk="1" latinLnBrk="0" hangingPunct="1">
        <a:lnSpc>
          <a:spcPct val="90000"/>
        </a:lnSpc>
        <a:spcBef>
          <a:spcPts val="1307"/>
        </a:spcBef>
        <a:buFont typeface="Arial" panose="020B0604020202020204" pitchFamily="34" charset="0"/>
        <a:buChar char="•"/>
        <a:defRPr sz="3659" kern="1200">
          <a:solidFill>
            <a:schemeClr val="tx1"/>
          </a:solidFill>
          <a:latin typeface="+mn-lt"/>
          <a:ea typeface="+mn-ea"/>
          <a:cs typeface="+mn-cs"/>
        </a:defRPr>
      </a:lvl1pPr>
      <a:lvl2pPr marL="896135" indent="-298712" algn="l" defTabSz="1194846" rtl="0" eaLnBrk="1" latinLnBrk="0" hangingPunct="1">
        <a:lnSpc>
          <a:spcPct val="90000"/>
        </a:lnSpc>
        <a:spcBef>
          <a:spcPts val="653"/>
        </a:spcBef>
        <a:buFont typeface="Arial" panose="020B0604020202020204" pitchFamily="34" charset="0"/>
        <a:buChar char="•"/>
        <a:defRPr sz="3136" kern="1200">
          <a:solidFill>
            <a:schemeClr val="tx1"/>
          </a:solidFill>
          <a:latin typeface="+mn-lt"/>
          <a:ea typeface="+mn-ea"/>
          <a:cs typeface="+mn-cs"/>
        </a:defRPr>
      </a:lvl2pPr>
      <a:lvl3pPr marL="1493558" indent="-298712" algn="l" defTabSz="1194846" rtl="0" eaLnBrk="1" latinLnBrk="0" hangingPunct="1">
        <a:lnSpc>
          <a:spcPct val="90000"/>
        </a:lnSpc>
        <a:spcBef>
          <a:spcPts val="653"/>
        </a:spcBef>
        <a:buFont typeface="Arial" panose="020B0604020202020204" pitchFamily="34" charset="0"/>
        <a:buChar char="•"/>
        <a:defRPr sz="2613" kern="1200">
          <a:solidFill>
            <a:schemeClr val="tx1"/>
          </a:solidFill>
          <a:latin typeface="+mn-lt"/>
          <a:ea typeface="+mn-ea"/>
          <a:cs typeface="+mn-cs"/>
        </a:defRPr>
      </a:lvl3pPr>
      <a:lvl4pPr marL="2090981" indent="-298712" algn="l" defTabSz="1194846" rtl="0" eaLnBrk="1" latinLnBrk="0" hangingPunct="1">
        <a:lnSpc>
          <a:spcPct val="90000"/>
        </a:lnSpc>
        <a:spcBef>
          <a:spcPts val="653"/>
        </a:spcBef>
        <a:buFont typeface="Arial" panose="020B0604020202020204" pitchFamily="34" charset="0"/>
        <a:buChar char="•"/>
        <a:defRPr sz="2352" kern="1200">
          <a:solidFill>
            <a:schemeClr val="tx1"/>
          </a:solidFill>
          <a:latin typeface="+mn-lt"/>
          <a:ea typeface="+mn-ea"/>
          <a:cs typeface="+mn-cs"/>
        </a:defRPr>
      </a:lvl4pPr>
      <a:lvl5pPr marL="2688405" indent="-298712" algn="l" defTabSz="1194846" rtl="0" eaLnBrk="1" latinLnBrk="0" hangingPunct="1">
        <a:lnSpc>
          <a:spcPct val="90000"/>
        </a:lnSpc>
        <a:spcBef>
          <a:spcPts val="653"/>
        </a:spcBef>
        <a:buFont typeface="Arial" panose="020B0604020202020204" pitchFamily="34" charset="0"/>
        <a:buChar char="•"/>
        <a:defRPr sz="2352" kern="1200">
          <a:solidFill>
            <a:schemeClr val="tx1"/>
          </a:solidFill>
          <a:latin typeface="+mn-lt"/>
          <a:ea typeface="+mn-ea"/>
          <a:cs typeface="+mn-cs"/>
        </a:defRPr>
      </a:lvl5pPr>
      <a:lvl6pPr marL="3285828" indent="-298712" algn="l" defTabSz="1194846" rtl="0" eaLnBrk="1" latinLnBrk="0" hangingPunct="1">
        <a:lnSpc>
          <a:spcPct val="90000"/>
        </a:lnSpc>
        <a:spcBef>
          <a:spcPts val="653"/>
        </a:spcBef>
        <a:buFont typeface="Arial" panose="020B0604020202020204" pitchFamily="34" charset="0"/>
        <a:buChar char="•"/>
        <a:defRPr sz="2352" kern="1200">
          <a:solidFill>
            <a:schemeClr val="tx1"/>
          </a:solidFill>
          <a:latin typeface="+mn-lt"/>
          <a:ea typeface="+mn-ea"/>
          <a:cs typeface="+mn-cs"/>
        </a:defRPr>
      </a:lvl6pPr>
      <a:lvl7pPr marL="3883251" indent="-298712" algn="l" defTabSz="1194846" rtl="0" eaLnBrk="1" latinLnBrk="0" hangingPunct="1">
        <a:lnSpc>
          <a:spcPct val="90000"/>
        </a:lnSpc>
        <a:spcBef>
          <a:spcPts val="653"/>
        </a:spcBef>
        <a:buFont typeface="Arial" panose="020B0604020202020204" pitchFamily="34" charset="0"/>
        <a:buChar char="•"/>
        <a:defRPr sz="2352" kern="1200">
          <a:solidFill>
            <a:schemeClr val="tx1"/>
          </a:solidFill>
          <a:latin typeface="+mn-lt"/>
          <a:ea typeface="+mn-ea"/>
          <a:cs typeface="+mn-cs"/>
        </a:defRPr>
      </a:lvl7pPr>
      <a:lvl8pPr marL="4480674" indent="-298712" algn="l" defTabSz="1194846" rtl="0" eaLnBrk="1" latinLnBrk="0" hangingPunct="1">
        <a:lnSpc>
          <a:spcPct val="90000"/>
        </a:lnSpc>
        <a:spcBef>
          <a:spcPts val="653"/>
        </a:spcBef>
        <a:buFont typeface="Arial" panose="020B0604020202020204" pitchFamily="34" charset="0"/>
        <a:buChar char="•"/>
        <a:defRPr sz="2352" kern="1200">
          <a:solidFill>
            <a:schemeClr val="tx1"/>
          </a:solidFill>
          <a:latin typeface="+mn-lt"/>
          <a:ea typeface="+mn-ea"/>
          <a:cs typeface="+mn-cs"/>
        </a:defRPr>
      </a:lvl8pPr>
      <a:lvl9pPr marL="5078098" indent="-298712" algn="l" defTabSz="1194846" rtl="0" eaLnBrk="1" latinLnBrk="0" hangingPunct="1">
        <a:lnSpc>
          <a:spcPct val="90000"/>
        </a:lnSpc>
        <a:spcBef>
          <a:spcPts val="653"/>
        </a:spcBef>
        <a:buFont typeface="Arial" panose="020B0604020202020204" pitchFamily="34" charset="0"/>
        <a:buChar char="•"/>
        <a:defRPr sz="235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194846" rtl="0" eaLnBrk="1" latinLnBrk="0" hangingPunct="1">
        <a:defRPr sz="2352" kern="1200">
          <a:solidFill>
            <a:schemeClr val="tx1"/>
          </a:solidFill>
          <a:latin typeface="+mn-lt"/>
          <a:ea typeface="+mn-ea"/>
          <a:cs typeface="+mn-cs"/>
        </a:defRPr>
      </a:lvl1pPr>
      <a:lvl2pPr marL="597423" algn="l" defTabSz="1194846" rtl="0" eaLnBrk="1" latinLnBrk="0" hangingPunct="1">
        <a:defRPr sz="2352" kern="1200">
          <a:solidFill>
            <a:schemeClr val="tx1"/>
          </a:solidFill>
          <a:latin typeface="+mn-lt"/>
          <a:ea typeface="+mn-ea"/>
          <a:cs typeface="+mn-cs"/>
        </a:defRPr>
      </a:lvl2pPr>
      <a:lvl3pPr marL="1194846" algn="l" defTabSz="1194846" rtl="0" eaLnBrk="1" latinLnBrk="0" hangingPunct="1">
        <a:defRPr sz="2352" kern="1200">
          <a:solidFill>
            <a:schemeClr val="tx1"/>
          </a:solidFill>
          <a:latin typeface="+mn-lt"/>
          <a:ea typeface="+mn-ea"/>
          <a:cs typeface="+mn-cs"/>
        </a:defRPr>
      </a:lvl3pPr>
      <a:lvl4pPr marL="1792270" algn="l" defTabSz="1194846" rtl="0" eaLnBrk="1" latinLnBrk="0" hangingPunct="1">
        <a:defRPr sz="2352" kern="1200">
          <a:solidFill>
            <a:schemeClr val="tx1"/>
          </a:solidFill>
          <a:latin typeface="+mn-lt"/>
          <a:ea typeface="+mn-ea"/>
          <a:cs typeface="+mn-cs"/>
        </a:defRPr>
      </a:lvl4pPr>
      <a:lvl5pPr marL="2389693" algn="l" defTabSz="1194846" rtl="0" eaLnBrk="1" latinLnBrk="0" hangingPunct="1">
        <a:defRPr sz="2352" kern="1200">
          <a:solidFill>
            <a:schemeClr val="tx1"/>
          </a:solidFill>
          <a:latin typeface="+mn-lt"/>
          <a:ea typeface="+mn-ea"/>
          <a:cs typeface="+mn-cs"/>
        </a:defRPr>
      </a:lvl5pPr>
      <a:lvl6pPr marL="2987116" algn="l" defTabSz="1194846" rtl="0" eaLnBrk="1" latinLnBrk="0" hangingPunct="1">
        <a:defRPr sz="2352" kern="1200">
          <a:solidFill>
            <a:schemeClr val="tx1"/>
          </a:solidFill>
          <a:latin typeface="+mn-lt"/>
          <a:ea typeface="+mn-ea"/>
          <a:cs typeface="+mn-cs"/>
        </a:defRPr>
      </a:lvl6pPr>
      <a:lvl7pPr marL="3584539" algn="l" defTabSz="1194846" rtl="0" eaLnBrk="1" latinLnBrk="0" hangingPunct="1">
        <a:defRPr sz="2352" kern="1200">
          <a:solidFill>
            <a:schemeClr val="tx1"/>
          </a:solidFill>
          <a:latin typeface="+mn-lt"/>
          <a:ea typeface="+mn-ea"/>
          <a:cs typeface="+mn-cs"/>
        </a:defRPr>
      </a:lvl7pPr>
      <a:lvl8pPr marL="4181963" algn="l" defTabSz="1194846" rtl="0" eaLnBrk="1" latinLnBrk="0" hangingPunct="1">
        <a:defRPr sz="2352" kern="1200">
          <a:solidFill>
            <a:schemeClr val="tx1"/>
          </a:solidFill>
          <a:latin typeface="+mn-lt"/>
          <a:ea typeface="+mn-ea"/>
          <a:cs typeface="+mn-cs"/>
        </a:defRPr>
      </a:lvl8pPr>
      <a:lvl9pPr marL="4779386" algn="l" defTabSz="1194846" rtl="0" eaLnBrk="1" latinLnBrk="0" hangingPunct="1">
        <a:defRPr sz="235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0" name="Google Shape;90;p2"/>
          <p:cNvGraphicFramePr/>
          <p:nvPr>
            <p:extLst>
              <p:ext uri="{D42A27DB-BD31-4B8C-83A1-F6EECF244321}">
                <p14:modId xmlns:p14="http://schemas.microsoft.com/office/powerpoint/2010/main" val="4142162015"/>
              </p:ext>
            </p:extLst>
          </p:nvPr>
        </p:nvGraphicFramePr>
        <p:xfrm>
          <a:off x="718457" y="274982"/>
          <a:ext cx="14308098" cy="8411474"/>
        </p:xfrm>
        <a:graphic>
          <a:graphicData uri="http://schemas.openxmlformats.org/drawingml/2006/table">
            <a:tbl>
              <a:tblPr firstRow="1" bandRow="1">
                <a:noFill/>
              </a:tblPr>
              <a:tblGrid>
                <a:gridCol w="120306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684200">
                  <a:extLst>
                    <a:ext uri="{9D8B030D-6E8A-4147-A177-3AD203B41FA5}">
                      <a16:colId xmlns:a16="http://schemas.microsoft.com/office/drawing/2014/main" val="2504895212"/>
                    </a:ext>
                  </a:extLst>
                </a:gridCol>
                <a:gridCol w="600970">
                  <a:extLst>
                    <a:ext uri="{9D8B030D-6E8A-4147-A177-3AD203B41FA5}">
                      <a16:colId xmlns:a16="http://schemas.microsoft.com/office/drawing/2014/main" val="3035821528"/>
                    </a:ext>
                  </a:extLst>
                </a:gridCol>
                <a:gridCol w="59678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596786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596786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596786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596786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617938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575598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596786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  <a:gridCol w="557115">
                  <a:extLst>
                    <a:ext uri="{9D8B030D-6E8A-4147-A177-3AD203B41FA5}">
                      <a16:colId xmlns:a16="http://schemas.microsoft.com/office/drawing/2014/main" val="20010"/>
                    </a:ext>
                  </a:extLst>
                </a:gridCol>
                <a:gridCol w="512430">
                  <a:extLst>
                    <a:ext uri="{9D8B030D-6E8A-4147-A177-3AD203B41FA5}">
                      <a16:colId xmlns:a16="http://schemas.microsoft.com/office/drawing/2014/main" val="20011"/>
                    </a:ext>
                  </a:extLst>
                </a:gridCol>
                <a:gridCol w="626365">
                  <a:extLst>
                    <a:ext uri="{9D8B030D-6E8A-4147-A177-3AD203B41FA5}">
                      <a16:colId xmlns:a16="http://schemas.microsoft.com/office/drawing/2014/main" val="20012"/>
                    </a:ext>
                  </a:extLst>
                </a:gridCol>
                <a:gridCol w="616262">
                  <a:extLst>
                    <a:ext uri="{9D8B030D-6E8A-4147-A177-3AD203B41FA5}">
                      <a16:colId xmlns:a16="http://schemas.microsoft.com/office/drawing/2014/main" val="20013"/>
                    </a:ext>
                  </a:extLst>
                </a:gridCol>
                <a:gridCol w="715338">
                  <a:extLst>
                    <a:ext uri="{9D8B030D-6E8A-4147-A177-3AD203B41FA5}">
                      <a16:colId xmlns:a16="http://schemas.microsoft.com/office/drawing/2014/main" val="20014"/>
                    </a:ext>
                  </a:extLst>
                </a:gridCol>
                <a:gridCol w="493820">
                  <a:extLst>
                    <a:ext uri="{9D8B030D-6E8A-4147-A177-3AD203B41FA5}">
                      <a16:colId xmlns:a16="http://schemas.microsoft.com/office/drawing/2014/main" val="20015"/>
                    </a:ext>
                  </a:extLst>
                </a:gridCol>
                <a:gridCol w="656169">
                  <a:extLst>
                    <a:ext uri="{9D8B030D-6E8A-4147-A177-3AD203B41FA5}">
                      <a16:colId xmlns:a16="http://schemas.microsoft.com/office/drawing/2014/main" val="20016"/>
                    </a:ext>
                  </a:extLst>
                </a:gridCol>
                <a:gridCol w="596786">
                  <a:extLst>
                    <a:ext uri="{9D8B030D-6E8A-4147-A177-3AD203B41FA5}">
                      <a16:colId xmlns:a16="http://schemas.microsoft.com/office/drawing/2014/main" val="20017"/>
                    </a:ext>
                  </a:extLst>
                </a:gridCol>
                <a:gridCol w="596786">
                  <a:extLst>
                    <a:ext uri="{9D8B030D-6E8A-4147-A177-3AD203B41FA5}">
                      <a16:colId xmlns:a16="http://schemas.microsoft.com/office/drawing/2014/main" val="20018"/>
                    </a:ext>
                  </a:extLst>
                </a:gridCol>
                <a:gridCol w="660585">
                  <a:extLst>
                    <a:ext uri="{9D8B030D-6E8A-4147-A177-3AD203B41FA5}">
                      <a16:colId xmlns:a16="http://schemas.microsoft.com/office/drawing/2014/main" val="20019"/>
                    </a:ext>
                  </a:extLst>
                </a:gridCol>
                <a:gridCol w="487540">
                  <a:extLst>
                    <a:ext uri="{9D8B030D-6E8A-4147-A177-3AD203B41FA5}">
                      <a16:colId xmlns:a16="http://schemas.microsoft.com/office/drawing/2014/main" val="20020"/>
                    </a:ext>
                  </a:extLst>
                </a:gridCol>
                <a:gridCol w="526419">
                  <a:extLst>
                    <a:ext uri="{9D8B030D-6E8A-4147-A177-3AD203B41FA5}">
                      <a16:colId xmlns:a16="http://schemas.microsoft.com/office/drawing/2014/main" val="20021"/>
                    </a:ext>
                  </a:extLst>
                </a:gridCol>
              </a:tblGrid>
              <a:tr h="567787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Tx/>
                        <a:buFont typeface="Arial"/>
                        <a:buNone/>
                        <a:tabLst/>
                        <a:defRPr/>
                      </a:pPr>
                      <a:r>
                        <a:rPr kumimoji="0" lang="en-US" sz="1000" b="1" i="0" u="none" strike="noStrike" kern="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Calibri"/>
                        </a:rPr>
                        <a:t>MGMT</a:t>
                      </a:r>
                      <a:endParaRPr kumimoji="0" lang="en-US" sz="10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cs typeface="Times New Roman" panose="02020603050405020304" pitchFamily="18" charset="0"/>
                        <a:sym typeface="Arial"/>
                      </a:endParaRPr>
                    </a:p>
                  </a:txBody>
                  <a:tcPr marL="119499" marR="119499" marT="59749" marB="5974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Tx/>
                        <a:buFont typeface="Arial"/>
                        <a:buNone/>
                        <a:tabLst/>
                        <a:defRPr/>
                      </a:pPr>
                      <a:r>
                        <a:rPr kumimoji="0" lang="en-US" sz="1000" b="1" i="0" u="none" strike="noStrike" kern="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  <a:sym typeface="Calibri"/>
                        </a:rPr>
                        <a:t>EGFR Amp</a:t>
                      </a:r>
                      <a:endParaRPr kumimoji="0" lang="en-US" sz="10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cs typeface="Times New Roman" panose="02020603050405020304" pitchFamily="18" charset="0"/>
                        <a:sym typeface="Arial"/>
                      </a:endParaRPr>
                    </a:p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B w="12700" cap="flat" cmpd="sng" algn="ctr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000" b="1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  <a:sym typeface="Calibri"/>
                        </a:rPr>
                        <a:t>CDK4 Amp</a:t>
                      </a:r>
                      <a:endParaRPr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000" b="1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  <a:sym typeface="Calibri"/>
                        </a:rPr>
                        <a:t>KDR Amp</a:t>
                      </a:r>
                      <a:endParaRPr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IT Amp</a:t>
                      </a:r>
                      <a:endParaRPr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0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DGFRA Amp</a:t>
                      </a:r>
                      <a:endParaRPr sz="10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LI1 Amp</a:t>
                      </a:r>
                      <a:endParaRPr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ERT</a:t>
                      </a:r>
                      <a:endParaRPr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0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P53</a:t>
                      </a:r>
                      <a:endParaRPr sz="10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KN2A/B</a:t>
                      </a:r>
                      <a:endParaRPr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B w="12700" cap="flat" cmpd="sng" algn="ctr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TEN</a:t>
                      </a:r>
                      <a:endParaRPr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EL</a:t>
                      </a:r>
                      <a:endParaRPr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TAP</a:t>
                      </a:r>
                      <a:endParaRPr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0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DHD</a:t>
                      </a:r>
                      <a:endParaRPr sz="10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ID1A</a:t>
                      </a:r>
                      <a:endParaRPr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BL</a:t>
                      </a:r>
                      <a:endParaRPr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ND2 Amp</a:t>
                      </a:r>
                      <a:endParaRPr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GF23 Amp</a:t>
                      </a:r>
                      <a:endParaRPr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GF6 Amp</a:t>
                      </a:r>
                      <a:endParaRPr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DM2 Amp</a:t>
                      </a:r>
                      <a:endParaRPr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B1</a:t>
                      </a:r>
                      <a:endParaRPr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CA1</a:t>
                      </a:r>
                      <a:endParaRPr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657814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0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Initial</a:t>
                      </a:r>
                      <a:endParaRPr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Recurrence</a:t>
                      </a:r>
                      <a:endParaRPr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900"/>
                        <a:buFont typeface="Calibri"/>
                        <a:buNone/>
                      </a:pPr>
                      <a:endParaRPr lang="en-US" sz="1200" b="0" i="0" u="none" strike="noStrike" cap="none" dirty="0">
                        <a:solidFill>
                          <a:schemeClr val="dk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  <a:sym typeface="Arial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900"/>
                        <a:buFont typeface="Calibri"/>
                        <a:buNone/>
                      </a:pPr>
                      <a:r>
                        <a:rPr lang="en-US" sz="1200" b="1" i="0" u="none" strike="noStrike" cap="none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−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900"/>
                        <a:buFont typeface="Calibri"/>
                        <a:buNone/>
                        <a:tabLst/>
                        <a:defRPr/>
                      </a:pPr>
                      <a:r>
                        <a:rPr lang="en-US" sz="1200" b="1" i="0" u="none" strike="noStrike" cap="none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−</a:t>
                      </a:r>
                    </a:p>
                  </a:txBody>
                  <a:tcPr marL="119499" marR="119499" marT="59749" marB="5974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bg1">
                        <a:lumMod val="65000"/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900"/>
                        <a:buFont typeface="Calibri"/>
                        <a:buNone/>
                      </a:pPr>
                      <a:endParaRPr lang="en-US" sz="1200" b="0" i="0" u="none" strike="noStrike" cap="none" dirty="0">
                        <a:solidFill>
                          <a:schemeClr val="dk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  <a:sym typeface="Arial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900"/>
                        <a:buFont typeface="Calibri"/>
                        <a:buNone/>
                      </a:pPr>
                      <a:endParaRPr lang="en-US" sz="1200" b="0" i="0" u="none" strike="noStrike" cap="none" dirty="0">
                        <a:solidFill>
                          <a:schemeClr val="dk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  <a:sym typeface="Arial"/>
                      </a:endParaRP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900"/>
                        <a:buFont typeface="Calibri"/>
                        <a:buNone/>
                        <a:tabLst/>
                        <a:defRPr/>
                      </a:pPr>
                      <a:r>
                        <a:rPr lang="en-US" sz="1200" b="0" dirty="0">
                          <a:solidFill>
                            <a:schemeClr val="accent2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●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bg1">
                        <a:lumMod val="65000"/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200" b="0" dirty="0">
                          <a:solidFill>
                            <a:srgbClr val="2F5496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●</a:t>
                      </a:r>
                      <a:endParaRPr sz="3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900"/>
                        <a:buFont typeface="Calibri"/>
                        <a:buNone/>
                      </a:pPr>
                      <a:endParaRPr sz="1200" b="0" dirty="0">
                        <a:solidFill>
                          <a:schemeClr val="accent2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bg1">
                        <a:lumMod val="65000"/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200" b="0" dirty="0">
                          <a:solidFill>
                            <a:srgbClr val="2F5496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●</a:t>
                      </a:r>
                      <a:endParaRPr sz="3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900"/>
                        <a:buFont typeface="Calibri"/>
                        <a:buNone/>
                      </a:pPr>
                      <a:endParaRPr sz="1200" b="0" dirty="0">
                        <a:solidFill>
                          <a:schemeClr val="dk1"/>
                        </a:solidFill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  <a:sym typeface="Calibri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200" b="0" dirty="0">
                          <a:solidFill>
                            <a:srgbClr val="2F5496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●</a:t>
                      </a:r>
                      <a:endParaRPr sz="3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900"/>
                        <a:buFont typeface="Calibri"/>
                        <a:buNone/>
                      </a:pPr>
                      <a:endParaRPr sz="1200" b="0" dirty="0">
                        <a:solidFill>
                          <a:schemeClr val="dk1"/>
                        </a:solidFill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  <a:sym typeface="Calibri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200" b="0">
                          <a:solidFill>
                            <a:srgbClr val="2F5496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●</a:t>
                      </a:r>
                      <a:endParaRPr sz="3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900"/>
                        <a:buFont typeface="Calibri"/>
                        <a:buNone/>
                      </a:pPr>
                      <a:endParaRPr sz="1200" b="0">
                        <a:solidFill>
                          <a:schemeClr val="dk1"/>
                        </a:solidFill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  <a:sym typeface="Calibri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200" b="0">
                          <a:solidFill>
                            <a:srgbClr val="2F5496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●</a:t>
                      </a:r>
                      <a:endParaRPr sz="3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900"/>
                        <a:buFont typeface="Calibri"/>
                        <a:buNone/>
                      </a:pPr>
                      <a:endParaRPr sz="1200" b="0">
                        <a:solidFill>
                          <a:schemeClr val="dk1"/>
                        </a:solidFill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  <a:sym typeface="Calibri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200" b="0">
                          <a:solidFill>
                            <a:srgbClr val="2F5496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●</a:t>
                      </a:r>
                      <a:endParaRPr sz="3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900"/>
                        <a:buFont typeface="Calibri"/>
                        <a:buNone/>
                      </a:pPr>
                      <a:endParaRPr sz="1200" b="0">
                        <a:solidFill>
                          <a:schemeClr val="dk1"/>
                        </a:solidFill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  <a:sym typeface="Calibri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200" b="0" dirty="0">
                          <a:solidFill>
                            <a:srgbClr val="2F5496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●</a:t>
                      </a:r>
                      <a:endParaRPr sz="3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900"/>
                        <a:buFont typeface="Calibri"/>
                        <a:buNone/>
                      </a:pPr>
                      <a:endParaRPr sz="1200" b="0" dirty="0">
                        <a:solidFill>
                          <a:schemeClr val="dk1"/>
                        </a:solidFill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  <a:sym typeface="Calibri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900"/>
                        <a:buFont typeface="Calibri"/>
                        <a:buNone/>
                      </a:pPr>
                      <a:endParaRPr sz="1200" b="0">
                        <a:solidFill>
                          <a:schemeClr val="dk1"/>
                        </a:solidFill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  <a:sym typeface="Calibri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837869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0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Initial</a:t>
                      </a:r>
                      <a:endParaRPr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Recurrence 1</a:t>
                      </a:r>
                      <a:endParaRPr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Recurrence 2</a:t>
                      </a:r>
                      <a:endParaRPr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900"/>
                        <a:buFont typeface="Calibri"/>
                        <a:buNone/>
                      </a:pPr>
                      <a:r>
                        <a:rPr lang="en-US" sz="1200" b="1" i="0" u="none" strike="noStrike" cap="none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−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900"/>
                        <a:buFont typeface="Calibri"/>
                        <a:buNone/>
                        <a:tabLst/>
                        <a:defRPr/>
                      </a:pPr>
                      <a:r>
                        <a:rPr lang="en-US" sz="1200" b="1" i="0" u="none" strike="noStrike" cap="none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−</a:t>
                      </a: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900"/>
                        <a:buFont typeface="Calibri"/>
                        <a:buNone/>
                      </a:pPr>
                      <a:endParaRPr lang="en-US" sz="1200" b="1" i="0" u="none" strike="noStrike" cap="none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  <a:sym typeface="Arial"/>
                      </a:endParaRPr>
                    </a:p>
                  </a:txBody>
                  <a:tcPr marL="119499" marR="119499" marT="59749" marB="5974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200" b="0" dirty="0">
                          <a:solidFill>
                            <a:srgbClr val="2F5496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●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accent2"/>
                        </a:buClr>
                        <a:buSzPts val="900"/>
                        <a:buFont typeface="Calibri"/>
                        <a:buNone/>
                      </a:pPr>
                      <a:r>
                        <a:rPr lang="en-US" sz="1200" b="0" dirty="0">
                          <a:solidFill>
                            <a:schemeClr val="accent2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●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FFC000"/>
                        </a:buClr>
                        <a:buSzPts val="900"/>
                        <a:buFont typeface="Calibri"/>
                        <a:buNone/>
                      </a:pPr>
                      <a:r>
                        <a:rPr lang="en-US" sz="1200" b="0" dirty="0">
                          <a:solidFill>
                            <a:srgbClr val="FFC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●</a:t>
                      </a: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b="0" dirty="0">
                        <a:solidFill>
                          <a:schemeClr val="dk1"/>
                        </a:solidFill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  <a:sym typeface="Calibri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b="0">
                        <a:solidFill>
                          <a:schemeClr val="dk1"/>
                        </a:solidFill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  <a:sym typeface="Calibri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b="0" dirty="0">
                        <a:solidFill>
                          <a:schemeClr val="dk1"/>
                        </a:solidFill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  <a:sym typeface="Calibri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b="0">
                        <a:solidFill>
                          <a:schemeClr val="dk1"/>
                        </a:solidFill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  <a:sym typeface="Calibri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b="0" dirty="0">
                        <a:solidFill>
                          <a:srgbClr val="2F5496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accent2"/>
                        </a:buClr>
                        <a:buSzPts val="900"/>
                        <a:buFont typeface="Calibri"/>
                        <a:buNone/>
                      </a:pPr>
                      <a:r>
                        <a:rPr lang="en-US" sz="1200" b="0" dirty="0">
                          <a:solidFill>
                            <a:schemeClr val="accent2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●</a:t>
                      </a:r>
                      <a:endParaRPr sz="3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FFC000"/>
                        </a:buClr>
                        <a:buSzPts val="900"/>
                        <a:buFont typeface="Calibri"/>
                        <a:buNone/>
                      </a:pPr>
                      <a:r>
                        <a:rPr lang="en-US" sz="1200" b="0" dirty="0">
                          <a:solidFill>
                            <a:srgbClr val="FFC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●</a:t>
                      </a:r>
                      <a:endParaRPr sz="3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900"/>
                        <a:buFont typeface="Calibri"/>
                        <a:buNone/>
                      </a:pPr>
                      <a:endParaRPr sz="1200" b="0">
                        <a:solidFill>
                          <a:srgbClr val="FFC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900"/>
                        <a:buFont typeface="Calibri"/>
                        <a:buNone/>
                      </a:pPr>
                      <a:endParaRPr sz="1200" b="0">
                        <a:solidFill>
                          <a:srgbClr val="FFC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900"/>
                        <a:buFont typeface="Calibri"/>
                        <a:buNone/>
                      </a:pPr>
                      <a:endParaRPr sz="1200" b="0">
                        <a:solidFill>
                          <a:srgbClr val="FFC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FFC000"/>
                        </a:buClr>
                        <a:buSzPts val="900"/>
                        <a:buFont typeface="Calibri"/>
                        <a:buNone/>
                      </a:pPr>
                      <a:r>
                        <a:rPr lang="en-US" sz="1200" b="0">
                          <a:solidFill>
                            <a:srgbClr val="FFC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●</a:t>
                      </a:r>
                      <a:endParaRPr sz="3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b="0">
                        <a:solidFill>
                          <a:srgbClr val="2F5496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accent2"/>
                        </a:buClr>
                        <a:buSzPts val="900"/>
                        <a:buFont typeface="Calibri"/>
                        <a:buNone/>
                      </a:pPr>
                      <a:r>
                        <a:rPr lang="en-US" sz="1200" b="0">
                          <a:solidFill>
                            <a:schemeClr val="accent2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●</a:t>
                      </a:r>
                      <a:endParaRPr sz="3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900"/>
                        <a:buFont typeface="Calibri"/>
                        <a:buNone/>
                      </a:pPr>
                      <a:endParaRPr sz="1200" b="0">
                        <a:solidFill>
                          <a:schemeClr val="dk1"/>
                        </a:solidFill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  <a:sym typeface="Calibri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b="0">
                        <a:solidFill>
                          <a:schemeClr val="dk1"/>
                        </a:solidFill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  <a:sym typeface="Calibri"/>
                      </a:endParaRPr>
                    </a:p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b="0">
                        <a:solidFill>
                          <a:schemeClr val="dk1"/>
                        </a:solidFill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  <a:sym typeface="Calibri"/>
                      </a:endParaRPr>
                    </a:p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b="0">
                        <a:solidFill>
                          <a:schemeClr val="dk1"/>
                        </a:solidFill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  <a:sym typeface="Calibri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FFC000"/>
                        </a:buClr>
                        <a:buSzPts val="900"/>
                        <a:buFont typeface="Calibri"/>
                        <a:buNone/>
                      </a:pPr>
                      <a:r>
                        <a:rPr lang="en-US" sz="1200" b="0">
                          <a:solidFill>
                            <a:srgbClr val="FFC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●</a:t>
                      </a:r>
                      <a:endParaRPr sz="3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b="0" dirty="0">
                        <a:solidFill>
                          <a:srgbClr val="2F5496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accent2"/>
                        </a:buClr>
                        <a:buSzPts val="900"/>
                        <a:buFont typeface="Calibri"/>
                        <a:buNone/>
                      </a:pPr>
                      <a:r>
                        <a:rPr lang="en-US" sz="1200" b="0" dirty="0">
                          <a:solidFill>
                            <a:schemeClr val="accent2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●</a:t>
                      </a:r>
                      <a:endParaRPr sz="3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900"/>
                        <a:buFont typeface="Calibri"/>
                        <a:buNone/>
                      </a:pPr>
                      <a:endParaRPr sz="1200" b="0" dirty="0">
                        <a:solidFill>
                          <a:schemeClr val="dk1"/>
                        </a:solidFill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  <a:sym typeface="Calibri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b="0" dirty="0">
                        <a:solidFill>
                          <a:srgbClr val="2F5496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accent2"/>
                        </a:buClr>
                        <a:buSzPts val="900"/>
                        <a:buFont typeface="Calibri"/>
                        <a:buNone/>
                      </a:pPr>
                      <a:r>
                        <a:rPr lang="en-US" sz="1200" b="0" dirty="0">
                          <a:solidFill>
                            <a:schemeClr val="accent2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●</a:t>
                      </a:r>
                      <a:endParaRPr sz="3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900"/>
                        <a:buFont typeface="Calibri"/>
                        <a:buNone/>
                      </a:pPr>
                      <a:endParaRPr sz="1200" b="0" dirty="0">
                        <a:solidFill>
                          <a:schemeClr val="dk1"/>
                        </a:solidFill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  <a:sym typeface="Calibri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b="0" dirty="0">
                        <a:solidFill>
                          <a:srgbClr val="2F5496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accent2"/>
                        </a:buClr>
                        <a:buSzPts val="900"/>
                        <a:buFont typeface="Calibri"/>
                        <a:buNone/>
                      </a:pPr>
                      <a:r>
                        <a:rPr lang="en-US" sz="1200" b="0" dirty="0">
                          <a:solidFill>
                            <a:schemeClr val="accent2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●</a:t>
                      </a:r>
                      <a:endParaRPr sz="3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900"/>
                        <a:buFont typeface="Calibri"/>
                        <a:buNone/>
                      </a:pPr>
                      <a:endParaRPr sz="1200" b="0" dirty="0">
                        <a:solidFill>
                          <a:schemeClr val="dk1"/>
                        </a:solidFill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  <a:sym typeface="Calibri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b="0" dirty="0">
                        <a:solidFill>
                          <a:schemeClr val="dk1"/>
                        </a:solidFill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  <a:sym typeface="Calibri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b="0">
                        <a:solidFill>
                          <a:schemeClr val="dk1"/>
                        </a:solidFill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  <a:sym typeface="Calibri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b="0">
                        <a:solidFill>
                          <a:schemeClr val="dk1"/>
                        </a:solidFill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  <a:sym typeface="Calibri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b="0" dirty="0">
                        <a:solidFill>
                          <a:schemeClr val="dk1"/>
                        </a:solidFill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  <a:sym typeface="Calibri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b="0">
                        <a:solidFill>
                          <a:schemeClr val="dk1"/>
                        </a:solidFill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  <a:sym typeface="Calibri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b="0">
                        <a:solidFill>
                          <a:schemeClr val="dk1"/>
                        </a:solidFill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  <a:sym typeface="Calibri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b="0">
                        <a:solidFill>
                          <a:schemeClr val="dk1"/>
                        </a:solidFill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  <a:sym typeface="Calibri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b="0">
                        <a:solidFill>
                          <a:schemeClr val="dk1"/>
                        </a:solidFill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  <a:sym typeface="Calibri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477760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0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0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</a:t>
                      </a:r>
                      <a:r>
                        <a:rPr lang="en-US" sz="10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itial</a:t>
                      </a:r>
                      <a:endParaRPr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Tx/>
                        <a:buFont typeface="Arial"/>
                        <a:buNone/>
                        <a:tabLst/>
                        <a:defRPr/>
                      </a:pPr>
                      <a:r>
                        <a:rPr lang="en-US" sz="1200" b="0" dirty="0">
                          <a:solidFill>
                            <a:srgbClr val="2F5496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●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900"/>
                        <a:buFont typeface="Calibri"/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b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b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b="0" dirty="0">
                        <a:solidFill>
                          <a:schemeClr val="dk1"/>
                        </a:solidFill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  <a:sym typeface="Calibri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b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b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b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b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b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b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b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b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b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657814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0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Initial</a:t>
                      </a:r>
                      <a:endParaRPr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Recurrence</a:t>
                      </a:r>
                      <a:endParaRPr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lang="en-US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Tx/>
                        <a:buFont typeface="Arial"/>
                        <a:buNone/>
                        <a:tabLst/>
                        <a:defRPr/>
                      </a:pPr>
                      <a:r>
                        <a:rPr lang="en-US" sz="12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900"/>
                        <a:buFont typeface="Calibri"/>
                        <a:buNone/>
                      </a:pPr>
                      <a:r>
                        <a:rPr lang="en-US" sz="1200" b="1" i="0" u="none" strike="noStrike" cap="none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−</a:t>
                      </a:r>
                    </a:p>
                  </a:txBody>
                  <a:tcPr marL="119499" marR="119499" marT="59749" marB="5974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b="0" dirty="0">
                        <a:solidFill>
                          <a:schemeClr val="dk1"/>
                        </a:solidFill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  <a:sym typeface="Calibri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b="0" dirty="0">
                        <a:solidFill>
                          <a:schemeClr val="dk1"/>
                        </a:solidFill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  <a:sym typeface="Calibri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b="0">
                        <a:solidFill>
                          <a:schemeClr val="dk1"/>
                        </a:solidFill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  <a:sym typeface="Calibri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b="0" dirty="0">
                        <a:solidFill>
                          <a:schemeClr val="dk1"/>
                        </a:solidFill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  <a:sym typeface="Calibri"/>
                      </a:endParaRPr>
                    </a:p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b="0" dirty="0">
                        <a:solidFill>
                          <a:schemeClr val="dk1"/>
                        </a:solidFill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  <a:sym typeface="Calibri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accent2"/>
                        </a:buClr>
                        <a:buSzPts val="900"/>
                        <a:buFont typeface="Calibri"/>
                        <a:buNone/>
                      </a:pPr>
                      <a:r>
                        <a:rPr lang="en-US" sz="1200" b="0" dirty="0">
                          <a:solidFill>
                            <a:schemeClr val="accent2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●</a:t>
                      </a:r>
                      <a:endParaRPr sz="3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b="0">
                        <a:solidFill>
                          <a:schemeClr val="dk1"/>
                        </a:solidFill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  <a:sym typeface="Calibri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b="0">
                        <a:solidFill>
                          <a:schemeClr val="dk1"/>
                        </a:solidFill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  <a:sym typeface="Calibri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b="0">
                        <a:solidFill>
                          <a:schemeClr val="dk1"/>
                        </a:solidFill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  <a:sym typeface="Calibri"/>
                      </a:endParaRPr>
                    </a:p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b="0">
                        <a:solidFill>
                          <a:schemeClr val="dk1"/>
                        </a:solidFill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  <a:sym typeface="Calibri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accent2"/>
                        </a:buClr>
                        <a:buSzPts val="900"/>
                        <a:buFont typeface="Calibri"/>
                        <a:buNone/>
                      </a:pPr>
                      <a:r>
                        <a:rPr lang="en-US" sz="1200" b="0">
                          <a:solidFill>
                            <a:schemeClr val="accent2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●</a:t>
                      </a:r>
                      <a:endParaRPr sz="3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b="0">
                        <a:solidFill>
                          <a:schemeClr val="dk1"/>
                        </a:solidFill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  <a:sym typeface="Calibri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b="0" dirty="0">
                        <a:solidFill>
                          <a:schemeClr val="dk1"/>
                        </a:solidFill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  <a:sym typeface="Calibri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b="0" dirty="0">
                        <a:solidFill>
                          <a:schemeClr val="dk1"/>
                        </a:solidFill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  <a:sym typeface="Calibri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b="0" dirty="0">
                        <a:solidFill>
                          <a:schemeClr val="dk1"/>
                        </a:solidFill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  <a:sym typeface="Calibri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b="0">
                        <a:solidFill>
                          <a:schemeClr val="dk1"/>
                        </a:solidFill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  <a:sym typeface="Calibri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b="0">
                        <a:solidFill>
                          <a:schemeClr val="dk1"/>
                        </a:solidFill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  <a:sym typeface="Calibri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b="0">
                        <a:solidFill>
                          <a:schemeClr val="dk1"/>
                        </a:solidFill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  <a:sym typeface="Calibri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b="0">
                        <a:solidFill>
                          <a:schemeClr val="dk1"/>
                        </a:solidFill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  <a:sym typeface="Calibri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b="0">
                        <a:solidFill>
                          <a:schemeClr val="dk1"/>
                        </a:solidFill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  <a:sym typeface="Calibri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900"/>
                        <a:buFont typeface="Calibri"/>
                        <a:buNone/>
                      </a:pPr>
                      <a:endParaRPr sz="1200" b="0">
                        <a:solidFill>
                          <a:schemeClr val="accent2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900"/>
                        <a:buFont typeface="Calibri"/>
                        <a:buNone/>
                      </a:pPr>
                      <a:endParaRPr sz="1200" b="0">
                        <a:solidFill>
                          <a:schemeClr val="accent2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accent2"/>
                        </a:buClr>
                        <a:buSzPts val="900"/>
                        <a:buFont typeface="Calibri"/>
                        <a:buNone/>
                      </a:pPr>
                      <a:r>
                        <a:rPr lang="en-US" sz="1200" b="0">
                          <a:solidFill>
                            <a:schemeClr val="accent2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●</a:t>
                      </a:r>
                      <a:endParaRPr sz="3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900"/>
                        <a:buFont typeface="Calibri"/>
                        <a:buNone/>
                      </a:pPr>
                      <a:endParaRPr sz="1200" b="0">
                        <a:solidFill>
                          <a:schemeClr val="accent2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477760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0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Initial</a:t>
                      </a:r>
                      <a:endParaRPr sz="10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lang="en-US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900"/>
                        <a:buFont typeface="Calibri"/>
                        <a:buNone/>
                      </a:pPr>
                      <a:r>
                        <a:rPr lang="en-US" sz="1200" b="1" i="0" u="none" strike="noStrike" cap="none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−</a:t>
                      </a:r>
                    </a:p>
                  </a:txBody>
                  <a:tcPr marL="119499" marR="119499" marT="59749" marB="5974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Tx/>
                        <a:buFont typeface="Arial"/>
                        <a:buNone/>
                        <a:tabLst/>
                        <a:defRPr/>
                      </a:pPr>
                      <a:r>
                        <a:rPr lang="en-US" sz="1200" b="0" dirty="0">
                          <a:solidFill>
                            <a:srgbClr val="2F5496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●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657814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0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Initial</a:t>
                      </a:r>
                    </a:p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0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</a:t>
                      </a:r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currence</a:t>
                      </a:r>
                      <a:endParaRPr lang="en-US" sz="10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lang="en-US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900"/>
                        <a:buFont typeface="Calibri"/>
                        <a:buNone/>
                      </a:pPr>
                      <a:r>
                        <a:rPr lang="en-US" sz="1200" b="1" i="0" u="none" strike="noStrike" cap="none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−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900"/>
                        <a:buFont typeface="Calibri"/>
                        <a:buNone/>
                        <a:tabLst/>
                        <a:defRPr/>
                      </a:pPr>
                      <a:r>
                        <a:rPr lang="en-US" sz="1200" b="1" i="0" u="none" strike="noStrike" cap="none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−</a:t>
                      </a:r>
                    </a:p>
                  </a:txBody>
                  <a:tcPr marL="119499" marR="119499" marT="59749" marB="5974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accent2"/>
                        </a:buClr>
                        <a:buSzPts val="900"/>
                        <a:buFont typeface="Calibri"/>
                        <a:buNone/>
                      </a:pP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42534374"/>
                  </a:ext>
                </a:extLst>
              </a:tr>
              <a:tr h="657814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0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  <a:endParaRPr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Initial</a:t>
                      </a:r>
                      <a:endParaRPr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Recurrence</a:t>
                      </a:r>
                      <a:endParaRPr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lang="en-US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900"/>
                        <a:buFont typeface="Calibri"/>
                        <a:buNone/>
                      </a:pPr>
                      <a:r>
                        <a:rPr lang="en-US" sz="1200" b="1" i="0" u="none" strike="noStrike" cap="none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−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900"/>
                        <a:buFont typeface="Calibri"/>
                        <a:buNone/>
                        <a:tabLst/>
                        <a:defRPr/>
                      </a:pPr>
                      <a:r>
                        <a:rPr lang="en-US" sz="1200" b="1" i="0" u="none" strike="noStrike" cap="none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−</a:t>
                      </a:r>
                    </a:p>
                  </a:txBody>
                  <a:tcPr marL="119499" marR="119499" marT="59749" marB="5974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200" b="0" dirty="0">
                          <a:solidFill>
                            <a:srgbClr val="2F5496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●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accent2"/>
                        </a:buClr>
                        <a:buSzPts val="900"/>
                        <a:buFont typeface="Calibri"/>
                        <a:buNone/>
                      </a:pPr>
                      <a:r>
                        <a:rPr lang="en-US" sz="1200" b="0" dirty="0">
                          <a:solidFill>
                            <a:schemeClr val="accent2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●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657814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0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Initial</a:t>
                      </a:r>
                    </a:p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0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</a:t>
                      </a:r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currence</a:t>
                      </a:r>
                      <a:endParaRPr lang="en-US" sz="10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Tx/>
                        <a:buFont typeface="Arial"/>
                        <a:buNone/>
                        <a:tabLst/>
                        <a:defRPr/>
                      </a:pPr>
                      <a:endParaRPr lang="en-US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900"/>
                        <a:buFont typeface="Calibri"/>
                        <a:buNone/>
                      </a:pPr>
                      <a:r>
                        <a:rPr lang="en-US" sz="1200" b="1" i="0" u="none" strike="noStrike" cap="none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−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900"/>
                        <a:buFont typeface="Calibri"/>
                        <a:buNone/>
                        <a:tabLst/>
                        <a:defRPr/>
                      </a:pPr>
                      <a:r>
                        <a:rPr lang="en-US" sz="1200" b="1" i="0" u="none" strike="noStrike" cap="none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−</a:t>
                      </a:r>
                    </a:p>
                  </a:txBody>
                  <a:tcPr marL="119499" marR="119499" marT="59749" marB="5974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28744034"/>
                  </a:ext>
                </a:extLst>
              </a:tr>
              <a:tr h="477760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0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  <a:endParaRPr 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Initial</a:t>
                      </a:r>
                    </a:p>
                  </a:txBody>
                  <a:tcPr marL="119499" marR="119499" marT="59749" marB="59749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lang="en-US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Tx/>
                        <a:buFont typeface="Arial"/>
                        <a:buNone/>
                        <a:tabLst/>
                        <a:defRPr/>
                      </a:pPr>
                      <a:r>
                        <a:rPr lang="en-US" sz="12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 marL="119499" marR="119499" marT="59749" marB="5974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96757044"/>
                  </a:ext>
                </a:extLst>
              </a:tr>
              <a:tr h="657814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0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Initial</a:t>
                      </a:r>
                      <a:endParaRPr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Recurrence</a:t>
                      </a:r>
                      <a:endParaRPr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lang="en-US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Tx/>
                        <a:buFont typeface="Arial"/>
                        <a:buNone/>
                        <a:tabLst/>
                        <a:defRPr/>
                      </a:pPr>
                      <a:r>
                        <a:rPr lang="en-US" sz="12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Tx/>
                        <a:buFont typeface="Arial"/>
                        <a:buNone/>
                        <a:tabLst/>
                        <a:defRPr/>
                      </a:pPr>
                      <a:r>
                        <a:rPr lang="en-US" sz="1200" b="0" dirty="0">
                          <a:solidFill>
                            <a:srgbClr val="2F5496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●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2F5496"/>
                        </a:buClr>
                        <a:buSzPts val="900"/>
                        <a:buFont typeface="Calibri"/>
                        <a:buNone/>
                      </a:pPr>
                      <a:r>
                        <a:rPr lang="en-US" sz="1200" b="0" dirty="0">
                          <a:solidFill>
                            <a:srgbClr val="2F5496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●</a:t>
                      </a:r>
                      <a:endParaRPr sz="3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2F5496"/>
                        </a:buClr>
                        <a:buSzPts val="900"/>
                        <a:buFont typeface="Calibri"/>
                        <a:buNone/>
                      </a:pPr>
                      <a:r>
                        <a:rPr lang="en-US" sz="1200" b="0" dirty="0">
                          <a:solidFill>
                            <a:srgbClr val="2F5496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●</a:t>
                      </a:r>
                      <a:endParaRPr sz="3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837869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0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</a:t>
                      </a:r>
                      <a:endParaRPr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Initial</a:t>
                      </a:r>
                      <a:endParaRPr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Recurrence 1</a:t>
                      </a:r>
                      <a:endParaRPr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Recurrence 2</a:t>
                      </a:r>
                      <a:endParaRPr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lang="en-US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Tx/>
                        <a:buFont typeface="Arial"/>
                        <a:buNone/>
                        <a:tabLst/>
                        <a:defRPr/>
                      </a:pPr>
                      <a:r>
                        <a:rPr lang="en-US" sz="12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Tx/>
                        <a:buFont typeface="Arial"/>
                        <a:buNone/>
                        <a:tabLst/>
                        <a:defRPr/>
                      </a:pPr>
                      <a:r>
                        <a:rPr lang="en-US" sz="12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200" b="0" dirty="0">
                          <a:solidFill>
                            <a:srgbClr val="2F5496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●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accent2"/>
                        </a:buClr>
                        <a:buSzPts val="900"/>
                        <a:buFont typeface="Calibri"/>
                        <a:buNone/>
                      </a:pPr>
                      <a:r>
                        <a:rPr lang="en-US" sz="1200" b="0" dirty="0">
                          <a:solidFill>
                            <a:schemeClr val="accent2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●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FFC000"/>
                        </a:buClr>
                        <a:buSzPts val="900"/>
                        <a:buFont typeface="Calibri"/>
                        <a:buNone/>
                      </a:pPr>
                      <a:r>
                        <a:rPr lang="en-US" sz="1200" b="0" dirty="0">
                          <a:solidFill>
                            <a:srgbClr val="FFC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●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2F5496"/>
                        </a:buClr>
                        <a:buSzPts val="900"/>
                        <a:buFont typeface="Calibri"/>
                        <a:buNone/>
                      </a:pPr>
                      <a:r>
                        <a:rPr lang="en-US" sz="1200" b="0">
                          <a:solidFill>
                            <a:srgbClr val="2F5496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●</a:t>
                      </a:r>
                      <a:endParaRPr sz="3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FFC000"/>
                        </a:buClr>
                        <a:buSzPts val="900"/>
                        <a:buFont typeface="Calibri"/>
                        <a:buNone/>
                      </a:pPr>
                      <a:r>
                        <a:rPr lang="en-US" sz="1200" b="0">
                          <a:solidFill>
                            <a:srgbClr val="FFC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●</a:t>
                      </a:r>
                      <a:endParaRPr sz="3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FFC000"/>
                        </a:buClr>
                        <a:buSzPts val="900"/>
                        <a:buFont typeface="Calibri"/>
                        <a:buNone/>
                      </a:pPr>
                      <a:r>
                        <a:rPr lang="en-US" sz="1200" b="0" dirty="0">
                          <a:solidFill>
                            <a:srgbClr val="FFC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●</a:t>
                      </a:r>
                      <a:endParaRPr sz="3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2F5496"/>
                        </a:buClr>
                        <a:buSzPts val="900"/>
                        <a:buFont typeface="Calibri"/>
                        <a:buNone/>
                      </a:pPr>
                      <a:r>
                        <a:rPr lang="en-US" sz="1200" b="0" dirty="0">
                          <a:solidFill>
                            <a:srgbClr val="2F5496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●</a:t>
                      </a:r>
                      <a:endParaRPr sz="3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FFC000"/>
                        </a:buClr>
                        <a:buSzPts val="900"/>
                        <a:buFont typeface="Calibri"/>
                        <a:buNone/>
                      </a:pPr>
                      <a:r>
                        <a:rPr lang="en-US" sz="1200" b="0" dirty="0">
                          <a:solidFill>
                            <a:srgbClr val="FFC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●</a:t>
                      </a:r>
                      <a:endParaRPr sz="3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2F5496"/>
                        </a:buClr>
                        <a:buSzPts val="900"/>
                        <a:buFont typeface="Calibri"/>
                        <a:buNone/>
                      </a:pPr>
                      <a:r>
                        <a:rPr lang="en-US" sz="1200" b="0" dirty="0">
                          <a:solidFill>
                            <a:srgbClr val="2F5496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●</a:t>
                      </a:r>
                      <a:endParaRPr sz="3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FFC000"/>
                        </a:buClr>
                        <a:buSzPts val="900"/>
                        <a:buFont typeface="Calibri"/>
                        <a:buNone/>
                      </a:pPr>
                      <a:r>
                        <a:rPr lang="en-US" sz="1200" b="0" dirty="0">
                          <a:solidFill>
                            <a:srgbClr val="FFC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●</a:t>
                      </a:r>
                      <a:endParaRPr sz="3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2F5496"/>
                        </a:buClr>
                        <a:buSzPts val="900"/>
                        <a:buFont typeface="Calibri"/>
                        <a:buNone/>
                      </a:pPr>
                      <a:r>
                        <a:rPr lang="en-US" sz="1200" b="0" dirty="0">
                          <a:solidFill>
                            <a:srgbClr val="2F5496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●</a:t>
                      </a:r>
                      <a:endParaRPr sz="3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FFC000"/>
                        </a:buClr>
                        <a:buSzPts val="900"/>
                        <a:buFont typeface="Calibri"/>
                        <a:buNone/>
                      </a:pPr>
                      <a:r>
                        <a:rPr lang="en-US" sz="1200" b="0" dirty="0">
                          <a:solidFill>
                            <a:srgbClr val="FFC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●</a:t>
                      </a:r>
                      <a:endParaRPr sz="3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2F5496"/>
                        </a:buClr>
                        <a:buSzPts val="900"/>
                        <a:buFont typeface="Calibri"/>
                        <a:buNone/>
                      </a:pPr>
                      <a:r>
                        <a:rPr lang="en-US" sz="1200" b="0">
                          <a:solidFill>
                            <a:srgbClr val="2F5496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●</a:t>
                      </a:r>
                      <a:endParaRPr sz="3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FFC000"/>
                        </a:buClr>
                        <a:buSzPts val="900"/>
                        <a:buFont typeface="Calibri"/>
                        <a:buNone/>
                      </a:pPr>
                      <a:r>
                        <a:rPr lang="en-US" sz="1200" b="0">
                          <a:solidFill>
                            <a:srgbClr val="FFC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●</a:t>
                      </a:r>
                      <a:endParaRPr sz="3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2F5496"/>
                        </a:buClr>
                        <a:buSzPts val="900"/>
                        <a:buFont typeface="Calibri"/>
                        <a:buNone/>
                      </a:pPr>
                      <a:r>
                        <a:rPr lang="en-US" sz="1200" b="0" dirty="0">
                          <a:solidFill>
                            <a:srgbClr val="2F5496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●</a:t>
                      </a:r>
                      <a:endParaRPr sz="3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FFC000"/>
                        </a:buClr>
                        <a:buSzPts val="900"/>
                        <a:buFont typeface="Calibri"/>
                        <a:buNone/>
                      </a:pPr>
                      <a:r>
                        <a:rPr lang="en-US" sz="1200" b="0" dirty="0">
                          <a:solidFill>
                            <a:srgbClr val="FFC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●</a:t>
                      </a:r>
                      <a:endParaRPr sz="3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FFC000"/>
                        </a:buClr>
                        <a:buSzPts val="900"/>
                        <a:buFont typeface="Calibri"/>
                        <a:buNone/>
                      </a:pPr>
                      <a:r>
                        <a:rPr lang="en-US" sz="1200" b="0" dirty="0">
                          <a:solidFill>
                            <a:srgbClr val="FFC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●</a:t>
                      </a:r>
                      <a:endParaRPr sz="3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657814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0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</a:t>
                      </a:r>
                      <a:endParaRPr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Initial</a:t>
                      </a:r>
                      <a:endParaRPr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Recurrence</a:t>
                      </a:r>
                      <a:endParaRPr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900"/>
                        <a:buFont typeface="Calibri"/>
                        <a:buNone/>
                      </a:pPr>
                      <a:r>
                        <a:rPr lang="en-US" sz="1200" b="1" i="0" u="none" strike="noStrike" cap="none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−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900"/>
                        <a:buFont typeface="Calibri"/>
                        <a:buNone/>
                        <a:tabLst/>
                        <a:defRPr/>
                      </a:pPr>
                      <a:endParaRPr lang="en-US" sz="1200" b="1" i="0" u="none" strike="noStrike" cap="none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  <a:sym typeface="Arial"/>
                      </a:endParaRPr>
                    </a:p>
                  </a:txBody>
                  <a:tcPr marL="119499" marR="119499" marT="59749" marB="59749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200" b="0" dirty="0">
                          <a:solidFill>
                            <a:srgbClr val="2F5496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●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accent2"/>
                        </a:buClr>
                        <a:buSzPts val="900"/>
                        <a:buFont typeface="Calibri"/>
                        <a:buNone/>
                      </a:pPr>
                      <a:r>
                        <a:rPr lang="en-US" sz="1200" b="0" dirty="0">
                          <a:solidFill>
                            <a:schemeClr val="accent2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●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2F5496"/>
                        </a:buClr>
                        <a:buSzPts val="900"/>
                        <a:buFont typeface="Calibri"/>
                        <a:buNone/>
                      </a:pPr>
                      <a:r>
                        <a:rPr lang="en-US" sz="1200" b="0" dirty="0">
                          <a:solidFill>
                            <a:srgbClr val="2F5496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●</a:t>
                      </a:r>
                      <a:endParaRPr sz="3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2F5496"/>
                        </a:buClr>
                        <a:buSzPts val="900"/>
                        <a:buFont typeface="Calibri"/>
                        <a:buNone/>
                      </a:pPr>
                      <a:r>
                        <a:rPr lang="en-US" sz="1200" b="0">
                          <a:solidFill>
                            <a:srgbClr val="2F5496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●</a:t>
                      </a:r>
                      <a:endParaRPr sz="3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2F5496"/>
                        </a:buClr>
                        <a:buSzPts val="900"/>
                        <a:buFont typeface="Calibri"/>
                        <a:buNone/>
                      </a:pPr>
                      <a:r>
                        <a:rPr lang="en-US" sz="1200" b="0" dirty="0">
                          <a:solidFill>
                            <a:srgbClr val="2F5496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●</a:t>
                      </a:r>
                      <a:endParaRPr sz="3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900"/>
                        <a:buFont typeface="Calibri"/>
                        <a:buNone/>
                      </a:pPr>
                      <a:endParaRPr sz="1200" b="0">
                        <a:solidFill>
                          <a:srgbClr val="2F5496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2F5496"/>
                        </a:buClr>
                        <a:buSzPts val="900"/>
                        <a:buFont typeface="Calibri"/>
                        <a:buNone/>
                      </a:pPr>
                      <a:r>
                        <a:rPr lang="en-US" sz="1200" b="0">
                          <a:solidFill>
                            <a:srgbClr val="2F5496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●</a:t>
                      </a:r>
                      <a:endParaRPr sz="3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2F5496"/>
                        </a:buClr>
                        <a:buSzPts val="900"/>
                        <a:buFont typeface="Calibri"/>
                        <a:buNone/>
                      </a:pPr>
                      <a:r>
                        <a:rPr lang="en-US" sz="1200" b="0">
                          <a:solidFill>
                            <a:srgbClr val="2F5496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●</a:t>
                      </a:r>
                      <a:endParaRPr sz="3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2F5496"/>
                        </a:buClr>
                        <a:buSzPts val="900"/>
                        <a:buFont typeface="Calibri"/>
                        <a:buNone/>
                      </a:pPr>
                      <a:r>
                        <a:rPr lang="en-US" sz="1200" b="0" dirty="0">
                          <a:solidFill>
                            <a:srgbClr val="2F5496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●</a:t>
                      </a:r>
                      <a:endParaRPr sz="3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9499" marR="119499" marT="59749" marB="59749">
                    <a:lnL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</a:tbl>
          </a:graphicData>
        </a:graphic>
      </p:graphicFrame>
      <p:sp>
        <p:nvSpPr>
          <p:cNvPr id="91" name="Google Shape;91;p2"/>
          <p:cNvSpPr/>
          <p:nvPr/>
        </p:nvSpPr>
        <p:spPr>
          <a:xfrm>
            <a:off x="331072" y="8681632"/>
            <a:ext cx="13818799" cy="33585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19466" tIns="59717" rIns="119466" bIns="59717" anchor="t" anchorCtr="0">
            <a:spAutoFit/>
          </a:bodyPr>
          <a:lstStyle/>
          <a:p>
            <a:pPr>
              <a:lnSpc>
                <a:spcPct val="107000"/>
              </a:lnSpc>
            </a:pPr>
            <a:r>
              <a:rPr lang="en-US" sz="1307" dirty="0">
                <a:solidFill>
                  <a:schemeClr val="dk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Legend: </a:t>
            </a:r>
            <a:r>
              <a:rPr lang="en-US" sz="1307" dirty="0">
                <a:solidFill>
                  <a:srgbClr val="2F5496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● </a:t>
            </a:r>
            <a:r>
              <a:rPr lang="en-US" sz="1307" dirty="0">
                <a:solidFill>
                  <a:schemeClr val="dk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= initial tumor; </a:t>
            </a:r>
            <a:r>
              <a:rPr lang="en-US" sz="1307" dirty="0">
                <a:solidFill>
                  <a:schemeClr val="accent2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● </a:t>
            </a:r>
            <a:r>
              <a:rPr lang="en-US" sz="1307" dirty="0">
                <a:solidFill>
                  <a:schemeClr val="dk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= recurrence #1; </a:t>
            </a:r>
            <a:r>
              <a:rPr lang="en-US" sz="1307" dirty="0">
                <a:solidFill>
                  <a:srgbClr val="FFC000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● </a:t>
            </a:r>
            <a:r>
              <a:rPr lang="en-US" sz="1307" dirty="0">
                <a:solidFill>
                  <a:schemeClr val="dk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= recurrence #2; + = detected; -- = not detected </a:t>
            </a:r>
            <a:endParaRPr sz="235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Google Shape;91;p2">
            <a:extLst>
              <a:ext uri="{FF2B5EF4-FFF2-40B4-BE49-F238E27FC236}">
                <a16:creationId xmlns:a16="http://schemas.microsoft.com/office/drawing/2014/main" id="{98E19537-A006-3048-AFAD-BE65DA22207A}"/>
              </a:ext>
            </a:extLst>
          </p:cNvPr>
          <p:cNvSpPr/>
          <p:nvPr/>
        </p:nvSpPr>
        <p:spPr>
          <a:xfrm>
            <a:off x="718457" y="-29920"/>
            <a:ext cx="13818799" cy="38407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19466" tIns="59717" rIns="119466" bIns="59717" anchor="t" anchorCtr="0">
            <a:spAutoFit/>
          </a:bodyPr>
          <a:lstStyle/>
          <a:p>
            <a:pPr>
              <a:lnSpc>
                <a:spcPct val="107000"/>
              </a:lnSpc>
            </a:pPr>
            <a:r>
              <a:rPr lang="en-US" sz="16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</a:t>
            </a:r>
            <a:r>
              <a:rPr lang="en-US" sz="1600" b="1" dirty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Table S3. Tumor molecular characteristics</a:t>
            </a:r>
            <a:endParaRPr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051882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631</TotalTime>
  <Words>202</Words>
  <Application>Microsoft Macintosh PowerPoint</Application>
  <PresentationFormat>Custom</PresentationFormat>
  <Paragraphs>20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dilia Hormigo</dc:creator>
  <cp:lastModifiedBy>Adilia Hormigo</cp:lastModifiedBy>
  <cp:revision>21</cp:revision>
  <dcterms:created xsi:type="dcterms:W3CDTF">2022-02-19T04:05:05Z</dcterms:created>
  <dcterms:modified xsi:type="dcterms:W3CDTF">2023-01-01T00:08:53Z</dcterms:modified>
</cp:coreProperties>
</file>